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69" r:id="rId3"/>
    <p:sldId id="266" r:id="rId4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713" autoAdjust="0"/>
    <p:restoredTop sz="92651" autoAdjust="0"/>
  </p:normalViewPr>
  <p:slideViewPr>
    <p:cSldViewPr snapToGrid="0">
      <p:cViewPr varScale="1">
        <p:scale>
          <a:sx n="73" d="100"/>
          <a:sy n="73" d="100"/>
        </p:scale>
        <p:origin x="1344" y="4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04B2F-58F6-4376-B5A1-9E683A0B50DD}" type="datetimeFigureOut">
              <a:rPr kumimoji="1" lang="ja-JP" altLang="en-US" smtClean="0"/>
              <a:t>2018/8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18FF6-920E-4709-BC5A-8FB7835349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15281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04B2F-58F6-4376-B5A1-9E683A0B50DD}" type="datetimeFigureOut">
              <a:rPr kumimoji="1" lang="ja-JP" altLang="en-US" smtClean="0"/>
              <a:t>2018/8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18FF6-920E-4709-BC5A-8FB7835349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2588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04B2F-58F6-4376-B5A1-9E683A0B50DD}" type="datetimeFigureOut">
              <a:rPr kumimoji="1" lang="ja-JP" altLang="en-US" smtClean="0"/>
              <a:t>2018/8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18FF6-920E-4709-BC5A-8FB7835349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4072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04B2F-58F6-4376-B5A1-9E683A0B50DD}" type="datetimeFigureOut">
              <a:rPr kumimoji="1" lang="ja-JP" altLang="en-US" smtClean="0"/>
              <a:t>2018/8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18FF6-920E-4709-BC5A-8FB7835349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6457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04B2F-58F6-4376-B5A1-9E683A0B50DD}" type="datetimeFigureOut">
              <a:rPr kumimoji="1" lang="ja-JP" altLang="en-US" smtClean="0"/>
              <a:t>2018/8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18FF6-920E-4709-BC5A-8FB7835349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3614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04B2F-58F6-4376-B5A1-9E683A0B50DD}" type="datetimeFigureOut">
              <a:rPr kumimoji="1" lang="ja-JP" altLang="en-US" smtClean="0"/>
              <a:t>2018/8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18FF6-920E-4709-BC5A-8FB7835349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91737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04B2F-58F6-4376-B5A1-9E683A0B50DD}" type="datetimeFigureOut">
              <a:rPr kumimoji="1" lang="ja-JP" altLang="en-US" smtClean="0"/>
              <a:t>2018/8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18FF6-920E-4709-BC5A-8FB7835349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2058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04B2F-58F6-4376-B5A1-9E683A0B50DD}" type="datetimeFigureOut">
              <a:rPr kumimoji="1" lang="ja-JP" altLang="en-US" smtClean="0"/>
              <a:t>2018/8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18FF6-920E-4709-BC5A-8FB7835349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89123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04B2F-58F6-4376-B5A1-9E683A0B50DD}" type="datetimeFigureOut">
              <a:rPr kumimoji="1" lang="ja-JP" altLang="en-US" smtClean="0"/>
              <a:t>2018/8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18FF6-920E-4709-BC5A-8FB7835349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5149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04B2F-58F6-4376-B5A1-9E683A0B50DD}" type="datetimeFigureOut">
              <a:rPr kumimoji="1" lang="ja-JP" altLang="en-US" smtClean="0"/>
              <a:t>2018/8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18FF6-920E-4709-BC5A-8FB7835349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0857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04B2F-58F6-4376-B5A1-9E683A0B50DD}" type="datetimeFigureOut">
              <a:rPr kumimoji="1" lang="ja-JP" altLang="en-US" smtClean="0"/>
              <a:t>2018/8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18FF6-920E-4709-BC5A-8FB7835349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6841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304B2F-58F6-4376-B5A1-9E683A0B50DD}" type="datetimeFigureOut">
              <a:rPr kumimoji="1" lang="ja-JP" altLang="en-US" smtClean="0"/>
              <a:t>2018/8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18FF6-920E-4709-BC5A-8FB7835349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061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75363" y="941733"/>
            <a:ext cx="602566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500" dirty="0"/>
              <a:t>Supp. Figure 1</a:t>
            </a:r>
            <a:endParaRPr lang="ja-JP" altLang="en-US" sz="15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4"/>
          <a:stretch/>
        </p:blipFill>
        <p:spPr bwMode="auto">
          <a:xfrm>
            <a:off x="2438399" y="4104745"/>
            <a:ext cx="3383341" cy="12968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49"/>
          <a:stretch/>
        </p:blipFill>
        <p:spPr bwMode="auto">
          <a:xfrm>
            <a:off x="2291738" y="1127587"/>
            <a:ext cx="3679895" cy="157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1883286" y="5305251"/>
            <a:ext cx="4096874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/>
              <a:t>Mt : </a:t>
            </a:r>
            <a:r>
              <a:rPr lang="en-US" altLang="ja-JP" sz="1050" dirty="0" err="1"/>
              <a:t>Wt</a:t>
            </a:r>
            <a:r>
              <a:rPr lang="en-US" altLang="ja-JP" sz="1050" dirty="0"/>
              <a:t> Ratios       1:10     1:100   1:1000  1:10000  1:100000  1 :100 </a:t>
            </a:r>
          </a:p>
          <a:p>
            <a:r>
              <a:rPr lang="en-US" altLang="ja-JP" sz="1050" dirty="0"/>
              <a:t>                                                                                                                           </a:t>
            </a:r>
          </a:p>
          <a:p>
            <a:r>
              <a:rPr lang="en-US" altLang="ja-JP" sz="1050" dirty="0"/>
              <a:t>                                                                                                            (I1171T) </a:t>
            </a:r>
            <a:endParaRPr lang="ja-JP" altLang="en-US" sz="1050" dirty="0"/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09"/>
          <a:stretch/>
        </p:blipFill>
        <p:spPr bwMode="auto">
          <a:xfrm>
            <a:off x="2325856" y="2591541"/>
            <a:ext cx="3654304" cy="1585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テキスト ボックス 8"/>
          <p:cNvSpPr txBox="1"/>
          <p:nvPr/>
        </p:nvSpPr>
        <p:spPr>
          <a:xfrm>
            <a:off x="2874250" y="4119823"/>
            <a:ext cx="5436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</a:rPr>
              <a:t>11.5%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367666" y="4117037"/>
            <a:ext cx="5436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</a:rPr>
              <a:t>1.03%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841593" y="4113904"/>
            <a:ext cx="5436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</a:rPr>
              <a:t>0.12%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282062" y="4111463"/>
            <a:ext cx="6582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</a:rPr>
              <a:t>0.038%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674525" y="1152403"/>
            <a:ext cx="26043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/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702070" y="2551492"/>
            <a:ext cx="26043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/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764226" y="4115524"/>
            <a:ext cx="19676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/>
              <a:t>C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9038BB1-C80E-4846-860A-AD800A553754}"/>
              </a:ext>
            </a:extLst>
          </p:cNvPr>
          <p:cNvSpPr txBox="1"/>
          <p:nvPr/>
        </p:nvSpPr>
        <p:spPr>
          <a:xfrm>
            <a:off x="1971913" y="1225887"/>
            <a:ext cx="353943" cy="137313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100" dirty="0"/>
              <a:t>Ch1 amplitude (FAM)</a:t>
            </a:r>
            <a:endParaRPr kumimoji="1" lang="ja-JP" altLang="en-US" sz="11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E3C7242-2B5D-44D4-9126-23226B5CF073}"/>
              </a:ext>
            </a:extLst>
          </p:cNvPr>
          <p:cNvSpPr txBox="1"/>
          <p:nvPr/>
        </p:nvSpPr>
        <p:spPr>
          <a:xfrm>
            <a:off x="1976265" y="2614906"/>
            <a:ext cx="353943" cy="137313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100" dirty="0"/>
              <a:t>Ch1 amplitude (HEX)</a:t>
            </a:r>
            <a:endParaRPr kumimoji="1" lang="ja-JP" altLang="en-US" sz="11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C8A4165-38A9-4458-B35C-A744D5848ED4}"/>
              </a:ext>
            </a:extLst>
          </p:cNvPr>
          <p:cNvSpPr txBox="1"/>
          <p:nvPr/>
        </p:nvSpPr>
        <p:spPr>
          <a:xfrm>
            <a:off x="2093836" y="4336865"/>
            <a:ext cx="400110" cy="63089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400" dirty="0"/>
              <a:t>Events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3220019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45155" y="857250"/>
            <a:ext cx="731559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altLang="ja-JP" sz="1500" dirty="0">
                <a:ea typeface="+mj-ea"/>
              </a:rPr>
              <a:t>Supp. Figure 2</a:t>
            </a:r>
            <a:endParaRPr lang="ja-JP" altLang="en-US" sz="1500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869064" y="1598384"/>
            <a:ext cx="25242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>
                <a:solidFill>
                  <a:prstClr val="black"/>
                </a:solidFill>
              </a:rPr>
              <a:t>A</a:t>
            </a:r>
            <a:endParaRPr lang="ja-JP" altLang="en-US" sz="1350" dirty="0">
              <a:solidFill>
                <a:prstClr val="black"/>
              </a:solidFill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4032809" y="960948"/>
            <a:ext cx="1681046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COSM144250 (26.5%)</a:t>
            </a:r>
            <a:endParaRPr lang="ja-JP" altLang="en-US" sz="1350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459631" y="5732339"/>
            <a:ext cx="75158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G1202R</a:t>
            </a:r>
            <a:endParaRPr lang="ja-JP" altLang="en-US" sz="1350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472072" y="5520848"/>
            <a:ext cx="75158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350" dirty="0"/>
              <a:t>     ↑</a:t>
            </a: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4E799241-CD9E-4C67-9EBE-AB4B6636C4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2397" y="1576396"/>
            <a:ext cx="7135756" cy="39100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40217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/>
          <p:cNvSpPr/>
          <p:nvPr/>
        </p:nvSpPr>
        <p:spPr>
          <a:xfrm>
            <a:off x="936702" y="1325605"/>
            <a:ext cx="1773044" cy="1087244"/>
          </a:xfrm>
          <a:prstGeom prst="rect">
            <a:avLst/>
          </a:prstGeom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142875" tIns="142875" rIns="142875" bIns="142875" numCol="1" spcCol="1270" anchor="ctr" anchorCtr="0">
            <a:noAutofit/>
          </a:bodyPr>
          <a:lstStyle/>
          <a:p>
            <a:pPr algn="ctr" defTabSz="1666875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ja-JP" altLang="en-US" sz="3750" dirty="0">
              <a:solidFill>
                <a:prstClr val="white"/>
              </a:solidFill>
            </a:endParaRPr>
          </a:p>
        </p:txBody>
      </p:sp>
      <p:pic>
        <p:nvPicPr>
          <p:cNvPr id="32" name="図 31"/>
          <p:cNvPicPr>
            <a:picLocks noChangeAspect="1"/>
          </p:cNvPicPr>
          <p:nvPr/>
        </p:nvPicPr>
        <p:blipFill rotWithShape="1">
          <a:blip r:embed="rId2"/>
          <a:srcRect l="3802"/>
          <a:stretch/>
        </p:blipFill>
        <p:spPr>
          <a:xfrm>
            <a:off x="644434" y="2544796"/>
            <a:ext cx="3554220" cy="2494746"/>
          </a:xfrm>
          <a:prstGeom prst="rect">
            <a:avLst/>
          </a:prstGeom>
        </p:spPr>
      </p:pic>
      <p:sp>
        <p:nvSpPr>
          <p:cNvPr id="43" name="テキスト ボックス 42"/>
          <p:cNvSpPr txBox="1"/>
          <p:nvPr/>
        </p:nvSpPr>
        <p:spPr>
          <a:xfrm>
            <a:off x="1123588" y="1536783"/>
            <a:ext cx="25242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>
                <a:solidFill>
                  <a:prstClr val="black"/>
                </a:solidFill>
              </a:rPr>
              <a:t>B</a:t>
            </a:r>
            <a:endParaRPr lang="ja-JP" altLang="en-US" sz="1350" dirty="0">
              <a:solidFill>
                <a:prstClr val="black"/>
              </a:solidFill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4619801" y="1586065"/>
            <a:ext cx="25242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>
                <a:solidFill>
                  <a:prstClr val="black"/>
                </a:solidFill>
              </a:rPr>
              <a:t>C</a:t>
            </a:r>
            <a:endParaRPr lang="ja-JP" altLang="en-US" sz="1350" dirty="0">
              <a:solidFill>
                <a:prstClr val="black"/>
              </a:solidFill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5155" y="857250"/>
            <a:ext cx="731559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altLang="ja-JP" sz="1500" dirty="0">
                <a:ea typeface="+mj-ea"/>
              </a:rPr>
              <a:t>Supp. Figure 2</a:t>
            </a:r>
            <a:endParaRPr lang="ja-JP" altLang="en-US" sz="1500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3"/>
          <a:srcRect l="26083" b="21764"/>
          <a:stretch/>
        </p:blipFill>
        <p:spPr>
          <a:xfrm>
            <a:off x="5503561" y="1783455"/>
            <a:ext cx="3554221" cy="2875631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BD232DB-8C14-4A17-93DB-02FDAAD7A14C}"/>
              </a:ext>
            </a:extLst>
          </p:cNvPr>
          <p:cNvSpPr txBox="1"/>
          <p:nvPr/>
        </p:nvSpPr>
        <p:spPr>
          <a:xfrm>
            <a:off x="5246346" y="1800356"/>
            <a:ext cx="307777" cy="101638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800" dirty="0"/>
              <a:t>Ch1 amplitude (FAM)</a:t>
            </a:r>
            <a:endParaRPr kumimoji="1" lang="ja-JP" altLang="en-US" sz="8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77E47CE-3303-4277-91E7-1FDEF932BC7E}"/>
              </a:ext>
            </a:extLst>
          </p:cNvPr>
          <p:cNvSpPr txBox="1"/>
          <p:nvPr/>
        </p:nvSpPr>
        <p:spPr>
          <a:xfrm>
            <a:off x="7367452" y="5234395"/>
            <a:ext cx="1393373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Resection of the brain metastasis</a:t>
            </a:r>
            <a:endParaRPr kumimoji="1" lang="ja-JP" altLang="en-US" sz="1400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FFA5DA7-45B4-4147-B30C-0DDCC893AA0D}"/>
              </a:ext>
            </a:extLst>
          </p:cNvPr>
          <p:cNvSpPr txBox="1"/>
          <p:nvPr/>
        </p:nvSpPr>
        <p:spPr>
          <a:xfrm>
            <a:off x="4798427" y="4638926"/>
            <a:ext cx="42593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After months </a:t>
            </a:r>
          </a:p>
          <a:p>
            <a:r>
              <a:rPr kumimoji="1" lang="en-US" altLang="ja-JP" sz="1400" dirty="0"/>
              <a:t>of </a:t>
            </a:r>
            <a:r>
              <a:rPr kumimoji="1" lang="en-US" altLang="ja-JP" sz="1400" dirty="0" err="1"/>
              <a:t>alectinib</a:t>
            </a:r>
            <a:r>
              <a:rPr kumimoji="1" lang="en-US" altLang="ja-JP" sz="1400" dirty="0"/>
              <a:t>               8         9      11      13                19     20</a:t>
            </a:r>
            <a:endParaRPr kumimoji="1" lang="ja-JP" altLang="en-US" sz="1400" dirty="0"/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B361AEAF-93A8-439B-940D-B49E56E5B867}"/>
              </a:ext>
            </a:extLst>
          </p:cNvPr>
          <p:cNvCxnSpPr>
            <a:cxnSpLocks/>
          </p:cNvCxnSpPr>
          <p:nvPr/>
        </p:nvCxnSpPr>
        <p:spPr>
          <a:xfrm>
            <a:off x="8072859" y="4685211"/>
            <a:ext cx="0" cy="522511"/>
          </a:xfrm>
          <a:prstGeom prst="line">
            <a:avLst/>
          </a:prstGeom>
          <a:ln w="285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234942A-47C9-4889-98D7-62DC3E31E42B}"/>
              </a:ext>
            </a:extLst>
          </p:cNvPr>
          <p:cNvSpPr txBox="1"/>
          <p:nvPr/>
        </p:nvSpPr>
        <p:spPr>
          <a:xfrm>
            <a:off x="352116" y="2680222"/>
            <a:ext cx="353943" cy="137313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100" dirty="0"/>
              <a:t>Ch1 amplitude (FAM)</a:t>
            </a:r>
            <a:endParaRPr kumimoji="1" lang="ja-JP" altLang="en-US" sz="11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93D339D-D364-4C3C-B6CB-7B2204E99D73}"/>
              </a:ext>
            </a:extLst>
          </p:cNvPr>
          <p:cNvSpPr txBox="1"/>
          <p:nvPr/>
        </p:nvSpPr>
        <p:spPr>
          <a:xfrm>
            <a:off x="2059567" y="4289508"/>
            <a:ext cx="139337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Ch2 amplitude (HEX)</a:t>
            </a:r>
            <a:endParaRPr kumimoji="1" lang="ja-JP" altLang="en-US" sz="11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2E7B269-149A-4440-9106-16F51EB9A99D}"/>
              </a:ext>
            </a:extLst>
          </p:cNvPr>
          <p:cNvSpPr txBox="1"/>
          <p:nvPr/>
        </p:nvSpPr>
        <p:spPr>
          <a:xfrm>
            <a:off x="5189736" y="2788781"/>
            <a:ext cx="307777" cy="101638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800" dirty="0"/>
              <a:t>Ch2 amplitude (HEX)</a:t>
            </a:r>
            <a:endParaRPr kumimoji="1" lang="ja-JP" altLang="en-US" sz="8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EB693D5-CC06-4F78-A293-9B78DF56569F}"/>
              </a:ext>
            </a:extLst>
          </p:cNvPr>
          <p:cNvSpPr txBox="1"/>
          <p:nvPr/>
        </p:nvSpPr>
        <p:spPr>
          <a:xfrm>
            <a:off x="5359557" y="4014648"/>
            <a:ext cx="307777" cy="430596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r>
              <a:rPr lang="en-US" altLang="ja-JP" sz="800" dirty="0"/>
              <a:t>Events</a:t>
            </a:r>
            <a:endParaRPr kumimoji="1" lang="ja-JP" altLang="en-US" sz="800" dirty="0"/>
          </a:p>
        </p:txBody>
      </p:sp>
    </p:spTree>
    <p:extLst>
      <p:ext uri="{BB962C8B-B14F-4D97-AF65-F5344CB8AC3E}">
        <p14:creationId xmlns:p14="http://schemas.microsoft.com/office/powerpoint/2010/main" val="23906397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0</TotalTime>
  <Words>97</Words>
  <Application>Microsoft Office PowerPoint</Application>
  <PresentationFormat>画面に合わせる (4:3)</PresentationFormat>
  <Paragraphs>30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吉田遼平</dc:creator>
  <cp:lastModifiedBy>吉田　遼平</cp:lastModifiedBy>
  <cp:revision>48</cp:revision>
  <dcterms:created xsi:type="dcterms:W3CDTF">2017-02-18T05:16:04Z</dcterms:created>
  <dcterms:modified xsi:type="dcterms:W3CDTF">2018-08-17T13:49:47Z</dcterms:modified>
</cp:coreProperties>
</file>